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152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342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9801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2578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124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8531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3310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92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7111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519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2044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4290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DEE2D-9158-40FB-A5A2-1DB09D9EB55C}" type="datetimeFigureOut">
              <a:rPr kumimoji="1" lang="ja-JP" altLang="en-US" smtClean="0"/>
              <a:t>2017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A60C3-116F-43D0-8952-557166FB12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747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/>
          <p:cNvGrpSpPr/>
          <p:nvPr/>
        </p:nvGrpSpPr>
        <p:grpSpPr>
          <a:xfrm>
            <a:off x="1300899" y="1150071"/>
            <a:ext cx="6357620" cy="4545104"/>
            <a:chOff x="1674017" y="1313654"/>
            <a:chExt cx="5400040" cy="3834765"/>
          </a:xfrm>
        </p:grpSpPr>
        <p:pic>
          <p:nvPicPr>
            <p:cNvPr id="4" name="図 3"/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1674017" y="1313654"/>
              <a:ext cx="5400040" cy="3834765"/>
            </a:xfrm>
            <a:prstGeom prst="rect">
              <a:avLst/>
            </a:prstGeom>
          </p:spPr>
        </p:pic>
        <p:sp>
          <p:nvSpPr>
            <p:cNvPr id="5" name="テキスト ボックス 4"/>
            <p:cNvSpPr txBox="1"/>
            <p:nvPr/>
          </p:nvSpPr>
          <p:spPr>
            <a:xfrm>
              <a:off x="5241303" y="3912123"/>
              <a:ext cx="1432059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13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P = 0.008</a:t>
              </a:r>
              <a:endParaRPr kumimoji="1" lang="ja-JP" altLang="en-US" sz="13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5222450" y="2582944"/>
              <a:ext cx="13179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VF history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4798245" y="1866507"/>
              <a:ext cx="15471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r>
                <a:rPr kumimoji="1"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thout VF history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 rot="16200000">
              <a:off x="1074655" y="2620651"/>
              <a:ext cx="194333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mulative survival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3695307" y="4760536"/>
              <a:ext cx="218681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 up periods (months)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10105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18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ya</dc:creator>
  <cp:lastModifiedBy>hiroya</cp:lastModifiedBy>
  <cp:revision>3</cp:revision>
  <dcterms:created xsi:type="dcterms:W3CDTF">2017-09-27T14:30:52Z</dcterms:created>
  <dcterms:modified xsi:type="dcterms:W3CDTF">2017-09-29T06:34:42Z</dcterms:modified>
</cp:coreProperties>
</file>